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3" r:id="rId2"/>
    <p:sldId id="294" r:id="rId3"/>
    <p:sldId id="286" r:id="rId4"/>
    <p:sldId id="29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784"/>
    <p:restoredTop sz="94694"/>
  </p:normalViewPr>
  <p:slideViewPr>
    <p:cSldViewPr snapToGrid="0" snapToObjects="1" showGuides="1">
      <p:cViewPr varScale="1">
        <p:scale>
          <a:sx n="95" d="100"/>
          <a:sy n="95" d="100"/>
        </p:scale>
        <p:origin x="208" y="38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4236E-AE0C-E143-9924-893B3DD87D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A52300-84EE-374B-9FA2-AEA757D888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971066-4C6B-CB4F-B25A-DBC4CE4B6E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52BF3A-D354-7D4B-AC99-95C46AE1F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4FD8B6-D1D8-1846-BBAE-A7C556358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411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11C1F-AFA5-AD49-ADFF-F1B7B10FE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70D28E-F698-864F-91CF-E6DF955377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1745AE-DBCE-D042-8093-248502C68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06320C-2973-D146-B0DB-B38A2395F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CF4858-E053-8E48-A5D5-EF447DEA7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782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A08DEE-95AB-8F43-958D-9B8FC302BD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5A4266-57B7-DD4D-91AD-21C0B1F31B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B5333A-4B78-FA4E-9DB0-E1874B91A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9EDE24-8FC6-D849-860D-E5D2EDE60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7A2007-4F1D-834B-BF6D-190A71C7D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557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12289-5106-9449-88D6-A6F04914AF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D3648A-F9C3-EB49-A34D-8EB873380C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77C893-2F5D-9044-BB78-CD922107D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5A78B-030D-7942-8A18-955313C19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AF4C27-13E4-0E48-BFE1-9B0EEB8F0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560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F90CC-5D30-9C48-9D98-442D6DA936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1ED252-8297-4848-AAE7-4376A06372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B1E220-0BE3-854D-BD3E-10A3F14C8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73A4DB-1742-3146-998E-5AB13DD09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E3DEEC-6F09-AA4F-A76D-BB4F85FA2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850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EB6350-C109-BD49-A01C-01C90C6F05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BCB09C-B481-944C-A920-750555A49F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38A828-CE59-BA42-B18D-13413EBD04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362C89-0B57-4742-88C6-1F26F7F27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AB6ADD-9AC7-2F4D-B1F2-07AECD39C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171922-7C82-DE47-B920-644303650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198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8B8E3-2548-8744-8326-A2E98A9D8D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D32936-66CC-0340-8C54-0F4269FE66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D3B55D-7402-6446-9DD7-BF6D1F5F72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7A028E-1B08-D846-880A-4000760C7D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3E9D8A-941B-3740-9738-0B15DB5B8E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3BA2A0-CC5A-134D-B8B5-AD9253648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2440DD-B1EC-6E40-BBC2-3C2265439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65AE92-5CA7-1B41-B770-4F61891F3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860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2F5F85-583B-424A-A40B-5B02D6727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EA9850-1357-FC46-98DA-D537AF1C2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8E4FC8-9876-2442-95CB-99192DD4D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6525F3-EEB4-3C4C-A0B1-70457C1F5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937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33C61C-1D54-EC4F-9CD6-C259C53BD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14B4212-48F4-804C-AEB2-BA20D98FF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90027D-A1E4-7846-868C-58F1D5650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553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622AE-99AF-3249-A216-DB788A4E8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A42A92-EE9C-E445-91D1-FB02135203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32F9DB-6BF7-CD49-A51D-B4A3CC9ADC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429452-EE99-0541-9B76-B05429AAC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F49A65-093C-CF44-8728-3537FF3A0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34AE73-BB0F-1A44-B27D-52DB308CD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312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89C3B5-668B-CA44-80FC-3EC1C251B3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9AF67C6-3646-F345-8CC2-27538900C3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8020E0-69D5-5C4A-92CC-0CD9B2AC4D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663123-5F65-6147-9140-806B46A70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26E5D0-9398-914B-815E-786F77327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235035-1B2E-0040-82AB-DFFA5C5DD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935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EE2422-D6F2-0E45-92DB-30F3DA60B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D9502F-0537-D04E-A0AC-1521CD9058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B599A4-DF5E-4F44-93D2-047BD88F68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7F9DD-97D3-A946-985B-052D5028D47F}" type="datetimeFigureOut">
              <a:rPr lang="en-US" smtClean="0"/>
              <a:t>8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785573-F0D7-9D43-9041-7B4741AFF9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78D10F-C646-BD45-AE08-52F58C7ADB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99DB4-FE3C-F747-8196-0E54C53926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991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6.png"/><Relationship Id="rId7" Type="http://schemas.microsoft.com/office/2007/relationships/hdphoto" Target="../media/hdphoto5.wdp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5" Type="http://schemas.microsoft.com/office/2007/relationships/hdphoto" Target="../media/hdphoto3.wdp"/><Relationship Id="rId4" Type="http://schemas.microsoft.com/office/2007/relationships/hdphoto" Target="../media/hdphoto2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644E633-9241-CC49-B1D9-57BD94DFBA8A}"/>
              </a:ext>
            </a:extLst>
          </p:cNvPr>
          <p:cNvSpPr txBox="1"/>
          <p:nvPr/>
        </p:nvSpPr>
        <p:spPr>
          <a:xfrm>
            <a:off x="136637" y="-53394"/>
            <a:ext cx="59383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Uncropped gels </a:t>
            </a:r>
            <a:r>
              <a:rPr lang="en-IL"/>
              <a:t>for </a:t>
            </a:r>
            <a:r>
              <a:rPr lang="en-US" dirty="0"/>
              <a:t>Extended Data Fig. 9</a:t>
            </a:r>
            <a:endParaRPr lang="en-IL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FA9502C4-D624-F14C-B09F-12003360FE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237" r="1"/>
          <a:stretch/>
        </p:blipFill>
        <p:spPr>
          <a:xfrm>
            <a:off x="228976" y="869009"/>
            <a:ext cx="2075884" cy="184361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4BBFB75E-F9A3-774D-A68A-87F341760A4A}"/>
              </a:ext>
            </a:extLst>
          </p:cNvPr>
          <p:cNvSpPr txBox="1"/>
          <p:nvPr/>
        </p:nvSpPr>
        <p:spPr>
          <a:xfrm>
            <a:off x="417821" y="869009"/>
            <a:ext cx="725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lnca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C10DE71-707D-BA4D-A4D2-8F87D4DE15CA}"/>
              </a:ext>
            </a:extLst>
          </p:cNvPr>
          <p:cNvSpPr txBox="1"/>
          <p:nvPr/>
        </p:nvSpPr>
        <p:spPr>
          <a:xfrm>
            <a:off x="1361340" y="869009"/>
            <a:ext cx="725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C4-2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02A8806B-9ADF-944D-AD92-6DD91995CF8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6237"/>
          <a:stretch/>
        </p:blipFill>
        <p:spPr>
          <a:xfrm>
            <a:off x="228977" y="2829047"/>
            <a:ext cx="2075884" cy="1752132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568A3B08-E90B-4543-8474-3F3E64C5AABC}"/>
              </a:ext>
            </a:extLst>
          </p:cNvPr>
          <p:cNvSpPr txBox="1"/>
          <p:nvPr/>
        </p:nvSpPr>
        <p:spPr>
          <a:xfrm>
            <a:off x="2743577" y="1421486"/>
            <a:ext cx="904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MDM4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397A7BCA-256A-BD4E-985F-A6B565EBEB9B}"/>
              </a:ext>
            </a:extLst>
          </p:cNvPr>
          <p:cNvCxnSpPr>
            <a:cxnSpLocks/>
          </p:cNvCxnSpPr>
          <p:nvPr/>
        </p:nvCxnSpPr>
        <p:spPr>
          <a:xfrm flipH="1">
            <a:off x="1958387" y="1639202"/>
            <a:ext cx="7851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17B759CF-D01A-104D-9736-FF3E3B80467E}"/>
              </a:ext>
            </a:extLst>
          </p:cNvPr>
          <p:cNvSpPr txBox="1"/>
          <p:nvPr/>
        </p:nvSpPr>
        <p:spPr>
          <a:xfrm>
            <a:off x="2876098" y="3476357"/>
            <a:ext cx="904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Tubulin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354B0DAE-11BE-2140-8100-B491D48348D8}"/>
              </a:ext>
            </a:extLst>
          </p:cNvPr>
          <p:cNvCxnSpPr>
            <a:cxnSpLocks/>
          </p:cNvCxnSpPr>
          <p:nvPr/>
        </p:nvCxnSpPr>
        <p:spPr>
          <a:xfrm flipH="1">
            <a:off x="2090908" y="3694073"/>
            <a:ext cx="7851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476539D5-5507-B94D-AC6D-5DE22BCA72D0}"/>
              </a:ext>
            </a:extLst>
          </p:cNvPr>
          <p:cNvSpPr/>
          <p:nvPr/>
        </p:nvSpPr>
        <p:spPr>
          <a:xfrm>
            <a:off x="1396127" y="1496350"/>
            <a:ext cx="562260" cy="246027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91130A9-5202-534F-83FF-6739D8A83DA5}"/>
              </a:ext>
            </a:extLst>
          </p:cNvPr>
          <p:cNvSpPr/>
          <p:nvPr/>
        </p:nvSpPr>
        <p:spPr>
          <a:xfrm>
            <a:off x="481728" y="1496351"/>
            <a:ext cx="661650" cy="294467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1B52F40E-6802-534C-B79C-A4FBCE5A5DA8}"/>
              </a:ext>
            </a:extLst>
          </p:cNvPr>
          <p:cNvSpPr/>
          <p:nvPr/>
        </p:nvSpPr>
        <p:spPr>
          <a:xfrm>
            <a:off x="490709" y="3509718"/>
            <a:ext cx="652669" cy="302609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B7D18D0D-9548-EA42-B411-6E7E518D42BD}"/>
              </a:ext>
            </a:extLst>
          </p:cNvPr>
          <p:cNvSpPr/>
          <p:nvPr/>
        </p:nvSpPr>
        <p:spPr>
          <a:xfrm>
            <a:off x="1388546" y="3513033"/>
            <a:ext cx="652669" cy="302609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3CE4BECB-8577-1B44-9C85-50D3E6D055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63748" y="869009"/>
            <a:ext cx="2232756" cy="2178098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972B4823-4E88-C145-A45E-408632CCD2E2}"/>
              </a:ext>
            </a:extLst>
          </p:cNvPr>
          <p:cNvSpPr txBox="1"/>
          <p:nvPr/>
        </p:nvSpPr>
        <p:spPr>
          <a:xfrm>
            <a:off x="4363748" y="869009"/>
            <a:ext cx="943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lncap9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EE67CA3-0401-F746-AA60-20486457E5D5}"/>
              </a:ext>
            </a:extLst>
          </p:cNvPr>
          <p:cNvSpPr txBox="1"/>
          <p:nvPr/>
        </p:nvSpPr>
        <p:spPr>
          <a:xfrm>
            <a:off x="5528620" y="887043"/>
            <a:ext cx="1627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</a:t>
            </a:r>
            <a:r>
              <a:rPr lang="en-IL" dirty="0"/>
              <a:t>ncap Abl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E9CBA33-D67C-5045-B6AB-51FF2F8CD832}"/>
              </a:ext>
            </a:extLst>
          </p:cNvPr>
          <p:cNvSpPr txBox="1"/>
          <p:nvPr/>
        </p:nvSpPr>
        <p:spPr>
          <a:xfrm>
            <a:off x="7155848" y="1485494"/>
            <a:ext cx="904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MDM4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4BD9567D-4C73-0544-B473-08E6E298B2F4}"/>
              </a:ext>
            </a:extLst>
          </p:cNvPr>
          <p:cNvCxnSpPr>
            <a:cxnSpLocks/>
          </p:cNvCxnSpPr>
          <p:nvPr/>
        </p:nvCxnSpPr>
        <p:spPr>
          <a:xfrm flipH="1">
            <a:off x="6416378" y="1660019"/>
            <a:ext cx="7851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98AF70AE-8034-9C4D-A21D-93BD658C8860}"/>
              </a:ext>
            </a:extLst>
          </p:cNvPr>
          <p:cNvSpPr/>
          <p:nvPr/>
        </p:nvSpPr>
        <p:spPr>
          <a:xfrm>
            <a:off x="5565789" y="1496352"/>
            <a:ext cx="868877" cy="310034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F888F95F-92F0-1541-AE57-1623980411B0}"/>
              </a:ext>
            </a:extLst>
          </p:cNvPr>
          <p:cNvSpPr/>
          <p:nvPr/>
        </p:nvSpPr>
        <p:spPr>
          <a:xfrm>
            <a:off x="4427654" y="1496351"/>
            <a:ext cx="868877" cy="294467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3EDA764C-4541-8048-A4A3-C10E458020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3748" y="3210774"/>
            <a:ext cx="2232756" cy="2005854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48B86400-4A18-8A48-BD14-79013AEFB64A}"/>
              </a:ext>
            </a:extLst>
          </p:cNvPr>
          <p:cNvSpPr txBox="1"/>
          <p:nvPr/>
        </p:nvSpPr>
        <p:spPr>
          <a:xfrm>
            <a:off x="7199183" y="4061054"/>
            <a:ext cx="904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Tubulin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00A3961-222F-BD46-984C-6AD79EB30AAE}"/>
              </a:ext>
            </a:extLst>
          </p:cNvPr>
          <p:cNvCxnSpPr>
            <a:cxnSpLocks/>
          </p:cNvCxnSpPr>
          <p:nvPr/>
        </p:nvCxnSpPr>
        <p:spPr>
          <a:xfrm flipH="1">
            <a:off x="6459713" y="4235579"/>
            <a:ext cx="7851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310E7F10-36BA-8045-A974-56E2BD3AC003}"/>
              </a:ext>
            </a:extLst>
          </p:cNvPr>
          <p:cNvSpPr/>
          <p:nvPr/>
        </p:nvSpPr>
        <p:spPr>
          <a:xfrm>
            <a:off x="5609124" y="4071912"/>
            <a:ext cx="868877" cy="310034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2713557A-E05F-5F4A-99B6-4BD0E4366EFA}"/>
              </a:ext>
            </a:extLst>
          </p:cNvPr>
          <p:cNvSpPr/>
          <p:nvPr/>
        </p:nvSpPr>
        <p:spPr>
          <a:xfrm>
            <a:off x="4470989" y="4071911"/>
            <a:ext cx="868877" cy="294467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924236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FC07F1E-249A-1249-A6B7-D4571D4AD7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724" t="51844" r="30086" b="39579"/>
          <a:stretch/>
        </p:blipFill>
        <p:spPr>
          <a:xfrm>
            <a:off x="5195385" y="2593412"/>
            <a:ext cx="2217683" cy="52551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1277584-B2B4-AC42-91EB-9659B161BF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042" t="51844" r="8406" b="40179"/>
          <a:stretch/>
        </p:blipFill>
        <p:spPr>
          <a:xfrm>
            <a:off x="7518171" y="2611804"/>
            <a:ext cx="2017986" cy="48873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D96DFE1-4F93-4F42-9972-66D2431F431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957" t="51844" r="52716" b="38722"/>
          <a:stretch/>
        </p:blipFill>
        <p:spPr>
          <a:xfrm>
            <a:off x="2977702" y="2593411"/>
            <a:ext cx="2112580" cy="52551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3645005-AFE8-EC4B-AE98-16E82297326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328" t="51844" r="75647" b="39579"/>
          <a:stretch/>
        </p:blipFill>
        <p:spPr>
          <a:xfrm>
            <a:off x="796805" y="2593411"/>
            <a:ext cx="2075794" cy="52551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59BCDAE-2804-3249-BA93-1D5884C40180}"/>
              </a:ext>
            </a:extLst>
          </p:cNvPr>
          <p:cNvSpPr txBox="1"/>
          <p:nvPr/>
        </p:nvSpPr>
        <p:spPr>
          <a:xfrm>
            <a:off x="9483514" y="2712761"/>
            <a:ext cx="764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8C98C41-5828-7E4B-A116-4B2BE426AA9A}"/>
              </a:ext>
            </a:extLst>
          </p:cNvPr>
          <p:cNvSpPr txBox="1"/>
          <p:nvPr/>
        </p:nvSpPr>
        <p:spPr>
          <a:xfrm>
            <a:off x="1480217" y="462092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0CCA34-3E6F-FA41-AAEB-C80C1CB95459}"/>
              </a:ext>
            </a:extLst>
          </p:cNvPr>
          <p:cNvSpPr txBox="1"/>
          <p:nvPr/>
        </p:nvSpPr>
        <p:spPr>
          <a:xfrm rot="16200000">
            <a:off x="603001" y="1210199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8C012FD-DC0C-7949-9082-5051EC45147A}"/>
              </a:ext>
            </a:extLst>
          </p:cNvPr>
          <p:cNvSpPr txBox="1"/>
          <p:nvPr/>
        </p:nvSpPr>
        <p:spPr>
          <a:xfrm>
            <a:off x="9536157" y="196955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DM4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9A18E3E-0A74-CC4A-B101-42CCEEE8E7A5}"/>
              </a:ext>
            </a:extLst>
          </p:cNvPr>
          <p:cNvCxnSpPr>
            <a:cxnSpLocks/>
          </p:cNvCxnSpPr>
          <p:nvPr/>
        </p:nvCxnSpPr>
        <p:spPr>
          <a:xfrm>
            <a:off x="994717" y="768820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1EF5C10-9BC9-DB4A-BB78-973149893F18}"/>
              </a:ext>
            </a:extLst>
          </p:cNvPr>
          <p:cNvSpPr txBox="1"/>
          <p:nvPr/>
        </p:nvSpPr>
        <p:spPr>
          <a:xfrm rot="16200000">
            <a:off x="1594949" y="1144885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91A76A-15E9-BD4A-8183-D2E4721BE1FC}"/>
              </a:ext>
            </a:extLst>
          </p:cNvPr>
          <p:cNvSpPr txBox="1"/>
          <p:nvPr/>
        </p:nvSpPr>
        <p:spPr>
          <a:xfrm rot="16200000">
            <a:off x="1080489" y="1203657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8D3C9D0-5873-3948-9F16-9C680388B087}"/>
              </a:ext>
            </a:extLst>
          </p:cNvPr>
          <p:cNvSpPr txBox="1"/>
          <p:nvPr/>
        </p:nvSpPr>
        <p:spPr>
          <a:xfrm rot="16200000">
            <a:off x="2087421" y="1144885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F1C31B-D5F3-714E-A681-E91780D27298}"/>
              </a:ext>
            </a:extLst>
          </p:cNvPr>
          <p:cNvSpPr txBox="1"/>
          <p:nvPr/>
        </p:nvSpPr>
        <p:spPr>
          <a:xfrm>
            <a:off x="3650599" y="467347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7D53C12-338A-694C-B283-1153F8C21BE2}"/>
              </a:ext>
            </a:extLst>
          </p:cNvPr>
          <p:cNvSpPr txBox="1"/>
          <p:nvPr/>
        </p:nvSpPr>
        <p:spPr>
          <a:xfrm rot="16200000">
            <a:off x="2773383" y="1215454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DFB38D6C-B35A-B84E-B447-A4DFC54C93BF}"/>
              </a:ext>
            </a:extLst>
          </p:cNvPr>
          <p:cNvCxnSpPr>
            <a:cxnSpLocks/>
          </p:cNvCxnSpPr>
          <p:nvPr/>
        </p:nvCxnSpPr>
        <p:spPr>
          <a:xfrm>
            <a:off x="3165099" y="774075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DFA9C5B6-B3B5-1A48-9BDC-ADB9D0240077}"/>
              </a:ext>
            </a:extLst>
          </p:cNvPr>
          <p:cNvSpPr txBox="1"/>
          <p:nvPr/>
        </p:nvSpPr>
        <p:spPr>
          <a:xfrm rot="16200000">
            <a:off x="3765331" y="1150140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8FA1D8F-0BDC-E945-A4CF-0A1BB6FCEEF6}"/>
              </a:ext>
            </a:extLst>
          </p:cNvPr>
          <p:cNvSpPr txBox="1"/>
          <p:nvPr/>
        </p:nvSpPr>
        <p:spPr>
          <a:xfrm rot="16200000">
            <a:off x="3250871" y="1208912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FEA3AF1-50CC-CA40-906F-DCA45726F2B7}"/>
              </a:ext>
            </a:extLst>
          </p:cNvPr>
          <p:cNvSpPr txBox="1"/>
          <p:nvPr/>
        </p:nvSpPr>
        <p:spPr>
          <a:xfrm rot="16200000">
            <a:off x="4257803" y="1150140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0712B2C-E7EF-B646-8F4C-7649B9C005A4}"/>
              </a:ext>
            </a:extLst>
          </p:cNvPr>
          <p:cNvSpPr txBox="1"/>
          <p:nvPr/>
        </p:nvSpPr>
        <p:spPr>
          <a:xfrm>
            <a:off x="5962866" y="467350"/>
            <a:ext cx="1008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 9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2882D71-AD5D-A44E-BE1A-7324F740D5D2}"/>
              </a:ext>
            </a:extLst>
          </p:cNvPr>
          <p:cNvSpPr txBox="1"/>
          <p:nvPr/>
        </p:nvSpPr>
        <p:spPr>
          <a:xfrm rot="16200000">
            <a:off x="5085650" y="1215457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A8B857C-BA66-2A49-A458-8498BE31CC4A}"/>
              </a:ext>
            </a:extLst>
          </p:cNvPr>
          <p:cNvCxnSpPr>
            <a:cxnSpLocks/>
          </p:cNvCxnSpPr>
          <p:nvPr/>
        </p:nvCxnSpPr>
        <p:spPr>
          <a:xfrm>
            <a:off x="5477366" y="774078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6EA9369-4AEC-AC4A-AB8D-9E1EEEB2E640}"/>
              </a:ext>
            </a:extLst>
          </p:cNvPr>
          <p:cNvSpPr txBox="1"/>
          <p:nvPr/>
        </p:nvSpPr>
        <p:spPr>
          <a:xfrm rot="16200000">
            <a:off x="6077598" y="115014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562B6BF-4A4F-FA4D-9274-77871178C645}"/>
              </a:ext>
            </a:extLst>
          </p:cNvPr>
          <p:cNvSpPr txBox="1"/>
          <p:nvPr/>
        </p:nvSpPr>
        <p:spPr>
          <a:xfrm rot="16200000">
            <a:off x="5563138" y="1208915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38CFA38-5B31-9043-8725-AD2A09C95D40}"/>
              </a:ext>
            </a:extLst>
          </p:cNvPr>
          <p:cNvSpPr txBox="1"/>
          <p:nvPr/>
        </p:nvSpPr>
        <p:spPr>
          <a:xfrm rot="16200000">
            <a:off x="6570070" y="115014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AE081C1-6395-FE4A-99B9-7F728EBD491E}"/>
              </a:ext>
            </a:extLst>
          </p:cNvPr>
          <p:cNvSpPr txBox="1"/>
          <p:nvPr/>
        </p:nvSpPr>
        <p:spPr>
          <a:xfrm>
            <a:off x="8170028" y="467349"/>
            <a:ext cx="10595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b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D5E2339-86C6-2D46-A525-8671CEF7C4BA}"/>
              </a:ext>
            </a:extLst>
          </p:cNvPr>
          <p:cNvSpPr txBox="1"/>
          <p:nvPr/>
        </p:nvSpPr>
        <p:spPr>
          <a:xfrm rot="16200000">
            <a:off x="7292812" y="1215456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AB95860-B540-B641-B64D-03144A1BC191}"/>
              </a:ext>
            </a:extLst>
          </p:cNvPr>
          <p:cNvCxnSpPr>
            <a:cxnSpLocks/>
          </p:cNvCxnSpPr>
          <p:nvPr/>
        </p:nvCxnSpPr>
        <p:spPr>
          <a:xfrm>
            <a:off x="7684528" y="774077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E207D6C0-2EA7-3F4E-B52C-316AD2EC9A8C}"/>
              </a:ext>
            </a:extLst>
          </p:cNvPr>
          <p:cNvSpPr txBox="1"/>
          <p:nvPr/>
        </p:nvSpPr>
        <p:spPr>
          <a:xfrm rot="16200000">
            <a:off x="8284760" y="1150142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C3D6411-F70F-A549-8145-AEEB687AAAD9}"/>
              </a:ext>
            </a:extLst>
          </p:cNvPr>
          <p:cNvSpPr txBox="1"/>
          <p:nvPr/>
        </p:nvSpPr>
        <p:spPr>
          <a:xfrm rot="16200000">
            <a:off x="7770300" y="1208914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03596FC-9BAF-F14D-987A-CEFFAEA727E5}"/>
              </a:ext>
            </a:extLst>
          </p:cNvPr>
          <p:cNvSpPr txBox="1"/>
          <p:nvPr/>
        </p:nvSpPr>
        <p:spPr>
          <a:xfrm rot="16200000">
            <a:off x="8777232" y="1150142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DA1EE117-3871-C94E-B850-67FF67E9578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7988" t="28339" r="73943" b="60088"/>
          <a:stretch/>
        </p:blipFill>
        <p:spPr>
          <a:xfrm>
            <a:off x="796804" y="1782732"/>
            <a:ext cx="2062223" cy="55103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F40552B6-27E6-044B-B2F0-89A7D7B7A7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0428" t="28339" r="50048" b="60366"/>
          <a:stretch/>
        </p:blipFill>
        <p:spPr>
          <a:xfrm>
            <a:off x="2977702" y="1783139"/>
            <a:ext cx="2112580" cy="56327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1E7641C9-195B-DA42-B449-9A23FF633AA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75027" t="28339" r="4350" b="61861"/>
          <a:stretch/>
        </p:blipFill>
        <p:spPr>
          <a:xfrm>
            <a:off x="7494676" y="1782732"/>
            <a:ext cx="2039935" cy="57712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117EED41-C165-7148-B81F-2BD6BD1374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52756" t="28339" r="27803" b="61167"/>
          <a:stretch/>
        </p:blipFill>
        <p:spPr>
          <a:xfrm>
            <a:off x="5194321" y="1786071"/>
            <a:ext cx="2217682" cy="56327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A915530F-A7A9-1447-ABE7-AAA75A60B4E7}"/>
              </a:ext>
            </a:extLst>
          </p:cNvPr>
          <p:cNvSpPr txBox="1"/>
          <p:nvPr/>
        </p:nvSpPr>
        <p:spPr>
          <a:xfrm>
            <a:off x="963148" y="2368907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2C3A3BE-CB96-EC4F-B5FE-64B27B607D97}"/>
              </a:ext>
            </a:extLst>
          </p:cNvPr>
          <p:cNvSpPr txBox="1"/>
          <p:nvPr/>
        </p:nvSpPr>
        <p:spPr>
          <a:xfrm>
            <a:off x="1420346" y="236365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DD5B409-DA9D-4048-BECA-E2E95EB43A56}"/>
              </a:ext>
            </a:extLst>
          </p:cNvPr>
          <p:cNvSpPr txBox="1"/>
          <p:nvPr/>
        </p:nvSpPr>
        <p:spPr>
          <a:xfrm>
            <a:off x="1935353" y="236365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39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0E64985-1A45-0643-84EB-791DD5B0163D}"/>
              </a:ext>
            </a:extLst>
          </p:cNvPr>
          <p:cNvSpPr txBox="1"/>
          <p:nvPr/>
        </p:nvSpPr>
        <p:spPr>
          <a:xfrm>
            <a:off x="2439846" y="237416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3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465D045-7513-034C-95E0-B7D212CB319D}"/>
              </a:ext>
            </a:extLst>
          </p:cNvPr>
          <p:cNvSpPr txBox="1"/>
          <p:nvPr/>
        </p:nvSpPr>
        <p:spPr>
          <a:xfrm>
            <a:off x="5372225" y="2374163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CB140B3-F56E-3F43-BD4A-85D79510CCB6}"/>
              </a:ext>
            </a:extLst>
          </p:cNvPr>
          <p:cNvSpPr txBox="1"/>
          <p:nvPr/>
        </p:nvSpPr>
        <p:spPr>
          <a:xfrm>
            <a:off x="5829423" y="2368910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8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1BAEAEF-3144-D54B-8297-8CB0A811BD67}"/>
              </a:ext>
            </a:extLst>
          </p:cNvPr>
          <p:cNvSpPr txBox="1"/>
          <p:nvPr/>
        </p:nvSpPr>
        <p:spPr>
          <a:xfrm>
            <a:off x="6344430" y="2368910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4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3ABBC06-3974-3347-BF25-4C8494451310}"/>
              </a:ext>
            </a:extLst>
          </p:cNvPr>
          <p:cNvSpPr txBox="1"/>
          <p:nvPr/>
        </p:nvSpPr>
        <p:spPr>
          <a:xfrm>
            <a:off x="6848923" y="2358400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5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A1709AC-A3FC-A344-97A1-D5F3076CDEE9}"/>
              </a:ext>
            </a:extLst>
          </p:cNvPr>
          <p:cNvSpPr txBox="1"/>
          <p:nvPr/>
        </p:nvSpPr>
        <p:spPr>
          <a:xfrm>
            <a:off x="3112508" y="236365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77478D5-6551-444E-BE13-078ABE473EDE}"/>
              </a:ext>
            </a:extLst>
          </p:cNvPr>
          <p:cNvSpPr txBox="1"/>
          <p:nvPr/>
        </p:nvSpPr>
        <p:spPr>
          <a:xfrm>
            <a:off x="3569706" y="235840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2.7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96B2691-9739-6A41-86E3-C249BC63E8C6}"/>
              </a:ext>
            </a:extLst>
          </p:cNvPr>
          <p:cNvSpPr txBox="1"/>
          <p:nvPr/>
        </p:nvSpPr>
        <p:spPr>
          <a:xfrm>
            <a:off x="4084713" y="235840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68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F59B636-B99D-E946-9F1C-232218A54044}"/>
              </a:ext>
            </a:extLst>
          </p:cNvPr>
          <p:cNvSpPr txBox="1"/>
          <p:nvPr/>
        </p:nvSpPr>
        <p:spPr>
          <a:xfrm>
            <a:off x="4589206" y="236891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6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AB24A36-A745-CA4F-BD88-0F91A8F2D8DD}"/>
              </a:ext>
            </a:extLst>
          </p:cNvPr>
          <p:cNvSpPr txBox="1"/>
          <p:nvPr/>
        </p:nvSpPr>
        <p:spPr>
          <a:xfrm>
            <a:off x="7621425" y="236365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BBC71D2-C1C6-3A4F-AE13-06B6A830F671}"/>
              </a:ext>
            </a:extLst>
          </p:cNvPr>
          <p:cNvSpPr txBox="1"/>
          <p:nvPr/>
        </p:nvSpPr>
        <p:spPr>
          <a:xfrm>
            <a:off x="8078623" y="235840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89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1C7C8CA-ECA3-2840-8360-2FD79B68F8DD}"/>
              </a:ext>
            </a:extLst>
          </p:cNvPr>
          <p:cNvSpPr txBox="1"/>
          <p:nvPr/>
        </p:nvSpPr>
        <p:spPr>
          <a:xfrm>
            <a:off x="8593630" y="235840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5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84943A9-B950-EF4F-B47C-BFA547C46CD0}"/>
              </a:ext>
            </a:extLst>
          </p:cNvPr>
          <p:cNvSpPr txBox="1"/>
          <p:nvPr/>
        </p:nvSpPr>
        <p:spPr>
          <a:xfrm>
            <a:off x="9098123" y="236891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27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4C9E1043-F0DC-BA4E-97DA-1F71938EBB6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704855" y="4266923"/>
            <a:ext cx="3699640" cy="1900319"/>
          </a:xfrm>
          <a:prstGeom prst="rect">
            <a:avLst/>
          </a:prstGeom>
        </p:spPr>
      </p:pic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68E1C030-4519-1243-B8D6-B6971E997EA9}"/>
              </a:ext>
            </a:extLst>
          </p:cNvPr>
          <p:cNvCxnSpPr/>
          <p:nvPr/>
        </p:nvCxnSpPr>
        <p:spPr>
          <a:xfrm flipH="1">
            <a:off x="10220565" y="4900641"/>
            <a:ext cx="51500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EEAF50AF-B752-3F41-9590-AD59C4565419}"/>
              </a:ext>
            </a:extLst>
          </p:cNvPr>
          <p:cNvSpPr txBox="1"/>
          <p:nvPr/>
        </p:nvSpPr>
        <p:spPr>
          <a:xfrm>
            <a:off x="10735572" y="4715975"/>
            <a:ext cx="1019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MDM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2E1A452-E305-ED43-9F9A-A5CBF4C1A3D6}"/>
              </a:ext>
            </a:extLst>
          </p:cNvPr>
          <p:cNvSpPr txBox="1"/>
          <p:nvPr/>
        </p:nvSpPr>
        <p:spPr>
          <a:xfrm>
            <a:off x="6896075" y="4381739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8E43022-1B5B-BC4F-9FC5-91BEFCB5BBF5}"/>
              </a:ext>
            </a:extLst>
          </p:cNvPr>
          <p:cNvSpPr txBox="1"/>
          <p:nvPr/>
        </p:nvSpPr>
        <p:spPr>
          <a:xfrm>
            <a:off x="7694523" y="4385054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750E3C9-6555-1247-8265-6536EF8C8F40}"/>
              </a:ext>
            </a:extLst>
          </p:cNvPr>
          <p:cNvSpPr txBox="1"/>
          <p:nvPr/>
        </p:nvSpPr>
        <p:spPr>
          <a:xfrm>
            <a:off x="9335848" y="4354810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bl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BDB53B6-FCB4-E64C-95DC-E31BDB9A7187}"/>
              </a:ext>
            </a:extLst>
          </p:cNvPr>
          <p:cNvSpPr txBox="1"/>
          <p:nvPr/>
        </p:nvSpPr>
        <p:spPr>
          <a:xfrm>
            <a:off x="8537400" y="4366714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95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1FF09837-D2B8-D54B-98AB-AA0699444E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3422" y="4222717"/>
            <a:ext cx="3580884" cy="1799428"/>
          </a:xfrm>
          <a:prstGeom prst="rect">
            <a:avLst/>
          </a:prstGeom>
        </p:spPr>
      </p:pic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18092A9F-E1B2-4441-85FE-0C4094EF9FB2}"/>
              </a:ext>
            </a:extLst>
          </p:cNvPr>
          <p:cNvCxnSpPr/>
          <p:nvPr/>
        </p:nvCxnSpPr>
        <p:spPr>
          <a:xfrm flipH="1">
            <a:off x="4464181" y="5223358"/>
            <a:ext cx="51500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1F4947A0-CBAF-3941-81CA-8BBCCD285E65}"/>
              </a:ext>
            </a:extLst>
          </p:cNvPr>
          <p:cNvSpPr txBox="1"/>
          <p:nvPr/>
        </p:nvSpPr>
        <p:spPr>
          <a:xfrm>
            <a:off x="4979188" y="5038692"/>
            <a:ext cx="1019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Tubulin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4417109-A9DB-A447-9B7F-FAD58E4BA6FD}"/>
              </a:ext>
            </a:extLst>
          </p:cNvPr>
          <p:cNvSpPr txBox="1"/>
          <p:nvPr/>
        </p:nvSpPr>
        <p:spPr>
          <a:xfrm>
            <a:off x="1323624" y="4304085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DBFC288-DD35-C74F-A1F4-B97AFF51846D}"/>
              </a:ext>
            </a:extLst>
          </p:cNvPr>
          <p:cNvSpPr txBox="1"/>
          <p:nvPr/>
        </p:nvSpPr>
        <p:spPr>
          <a:xfrm>
            <a:off x="2122072" y="4307400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3E23E4D-0B20-BF4D-8E56-16853991EE1D}"/>
              </a:ext>
            </a:extLst>
          </p:cNvPr>
          <p:cNvSpPr txBox="1"/>
          <p:nvPr/>
        </p:nvSpPr>
        <p:spPr>
          <a:xfrm>
            <a:off x="3763397" y="4287095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bl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CA7201E-0284-7840-B6D0-10D9B21A8EF1}"/>
              </a:ext>
            </a:extLst>
          </p:cNvPr>
          <p:cNvSpPr txBox="1"/>
          <p:nvPr/>
        </p:nvSpPr>
        <p:spPr>
          <a:xfrm>
            <a:off x="2964949" y="4298999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95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3DB821C-FE33-9645-811C-CDE5BCE7050F}"/>
              </a:ext>
            </a:extLst>
          </p:cNvPr>
          <p:cNvSpPr txBox="1"/>
          <p:nvPr/>
        </p:nvSpPr>
        <p:spPr>
          <a:xfrm>
            <a:off x="-1" y="0"/>
            <a:ext cx="3165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Rep1 </a:t>
            </a:r>
            <a:r>
              <a:rPr lang="en-IL"/>
              <a:t>of </a:t>
            </a:r>
            <a:r>
              <a:rPr lang="en-US" dirty="0"/>
              <a:t>Extended Data Fig. 9</a:t>
            </a:r>
            <a:endParaRPr lang="en-IL" dirty="0"/>
          </a:p>
        </p:txBody>
      </p:sp>
    </p:spTree>
    <p:extLst>
      <p:ext uri="{BB962C8B-B14F-4D97-AF65-F5344CB8AC3E}">
        <p14:creationId xmlns:p14="http://schemas.microsoft.com/office/powerpoint/2010/main" val="2696508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9781AAE-A713-AB4D-A658-56F99A566CD2}"/>
              </a:ext>
            </a:extLst>
          </p:cNvPr>
          <p:cNvSpPr txBox="1"/>
          <p:nvPr/>
        </p:nvSpPr>
        <p:spPr>
          <a:xfrm>
            <a:off x="9995337" y="2962440"/>
            <a:ext cx="764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6257AE-37A2-C44E-8427-57470A43F11E}"/>
              </a:ext>
            </a:extLst>
          </p:cNvPr>
          <p:cNvSpPr txBox="1"/>
          <p:nvPr/>
        </p:nvSpPr>
        <p:spPr>
          <a:xfrm>
            <a:off x="1939397" y="522555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F0ED3AC-A08B-0241-BDD6-EF37BE540E6B}"/>
              </a:ext>
            </a:extLst>
          </p:cNvPr>
          <p:cNvSpPr txBox="1"/>
          <p:nvPr/>
        </p:nvSpPr>
        <p:spPr>
          <a:xfrm rot="16200000">
            <a:off x="1062181" y="1270662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B2EC78-D14F-1740-80BF-292FFB627F40}"/>
              </a:ext>
            </a:extLst>
          </p:cNvPr>
          <p:cNvSpPr txBox="1"/>
          <p:nvPr/>
        </p:nvSpPr>
        <p:spPr>
          <a:xfrm>
            <a:off x="9995337" y="2030018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DM4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1C80C41-929B-4E49-AEAB-A36E814947BD}"/>
              </a:ext>
            </a:extLst>
          </p:cNvPr>
          <p:cNvCxnSpPr>
            <a:cxnSpLocks/>
          </p:cNvCxnSpPr>
          <p:nvPr/>
        </p:nvCxnSpPr>
        <p:spPr>
          <a:xfrm>
            <a:off x="1453897" y="829283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4C3C7CE6-1F94-0845-A2DE-E9B778487AA8}"/>
              </a:ext>
            </a:extLst>
          </p:cNvPr>
          <p:cNvSpPr txBox="1"/>
          <p:nvPr/>
        </p:nvSpPr>
        <p:spPr>
          <a:xfrm rot="16200000">
            <a:off x="1949825" y="1228310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932C886-FE29-1046-A67F-CA58BA45475C}"/>
              </a:ext>
            </a:extLst>
          </p:cNvPr>
          <p:cNvSpPr txBox="1"/>
          <p:nvPr/>
        </p:nvSpPr>
        <p:spPr>
          <a:xfrm rot="16200000">
            <a:off x="1539669" y="1264120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0B6856-3703-DF46-83B5-463505DBC29E}"/>
              </a:ext>
            </a:extLst>
          </p:cNvPr>
          <p:cNvSpPr txBox="1"/>
          <p:nvPr/>
        </p:nvSpPr>
        <p:spPr>
          <a:xfrm rot="16200000">
            <a:off x="2365554" y="1237087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843B1D-2779-224A-990A-713FFB64ACF9}"/>
              </a:ext>
            </a:extLst>
          </p:cNvPr>
          <p:cNvSpPr txBox="1"/>
          <p:nvPr/>
        </p:nvSpPr>
        <p:spPr>
          <a:xfrm>
            <a:off x="4109779" y="527810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D3D560-D096-734D-A1B4-B3D61B2934B3}"/>
              </a:ext>
            </a:extLst>
          </p:cNvPr>
          <p:cNvSpPr txBox="1"/>
          <p:nvPr/>
        </p:nvSpPr>
        <p:spPr>
          <a:xfrm rot="16200000">
            <a:off x="3393962" y="1330364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F5F83E7-070C-CC4A-A288-B69C24151244}"/>
              </a:ext>
            </a:extLst>
          </p:cNvPr>
          <p:cNvCxnSpPr>
            <a:cxnSpLocks/>
          </p:cNvCxnSpPr>
          <p:nvPr/>
        </p:nvCxnSpPr>
        <p:spPr>
          <a:xfrm>
            <a:off x="3624279" y="834538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F53A856-AE7C-7B45-930B-A81E1A6C6AB2}"/>
              </a:ext>
            </a:extLst>
          </p:cNvPr>
          <p:cNvSpPr txBox="1"/>
          <p:nvPr/>
        </p:nvSpPr>
        <p:spPr>
          <a:xfrm rot="16200000">
            <a:off x="4194983" y="1286846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A86CC8E-EE93-E649-B111-A620A4071DA0}"/>
              </a:ext>
            </a:extLst>
          </p:cNvPr>
          <p:cNvSpPr txBox="1"/>
          <p:nvPr/>
        </p:nvSpPr>
        <p:spPr>
          <a:xfrm rot="16200000">
            <a:off x="3800513" y="1298805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7E6E487-77AB-164D-BD5E-43755FFDB73B}"/>
              </a:ext>
            </a:extLst>
          </p:cNvPr>
          <p:cNvSpPr txBox="1"/>
          <p:nvPr/>
        </p:nvSpPr>
        <p:spPr>
          <a:xfrm rot="16200000">
            <a:off x="4648757" y="1286845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277DD21-39F1-5C44-8AF4-E1C907A80B60}"/>
              </a:ext>
            </a:extLst>
          </p:cNvPr>
          <p:cNvSpPr txBox="1"/>
          <p:nvPr/>
        </p:nvSpPr>
        <p:spPr>
          <a:xfrm>
            <a:off x="6422046" y="527813"/>
            <a:ext cx="1008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 9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E248482-2829-F945-8709-18CD82CD0B28}"/>
              </a:ext>
            </a:extLst>
          </p:cNvPr>
          <p:cNvSpPr txBox="1"/>
          <p:nvPr/>
        </p:nvSpPr>
        <p:spPr>
          <a:xfrm rot="16200000">
            <a:off x="5564812" y="1360267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6080645-4339-6644-B495-C48370698C39}"/>
              </a:ext>
            </a:extLst>
          </p:cNvPr>
          <p:cNvCxnSpPr>
            <a:cxnSpLocks/>
          </p:cNvCxnSpPr>
          <p:nvPr/>
        </p:nvCxnSpPr>
        <p:spPr>
          <a:xfrm>
            <a:off x="5936546" y="834541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0258CA3-8B98-754D-B600-9F83B3329FF8}"/>
              </a:ext>
            </a:extLst>
          </p:cNvPr>
          <p:cNvSpPr txBox="1"/>
          <p:nvPr/>
        </p:nvSpPr>
        <p:spPr>
          <a:xfrm rot="16200000">
            <a:off x="6420458" y="1293844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372631D-B5CE-9148-88D0-99E448210EED}"/>
              </a:ext>
            </a:extLst>
          </p:cNvPr>
          <p:cNvSpPr txBox="1"/>
          <p:nvPr/>
        </p:nvSpPr>
        <p:spPr>
          <a:xfrm rot="16200000">
            <a:off x="6022318" y="1360266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F09FBBB-366A-A747-AC41-8095A6CB2031}"/>
              </a:ext>
            </a:extLst>
          </p:cNvPr>
          <p:cNvSpPr txBox="1"/>
          <p:nvPr/>
        </p:nvSpPr>
        <p:spPr>
          <a:xfrm rot="16200000">
            <a:off x="6883545" y="1294606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D055530-7002-524A-BD16-D21F944FB76E}"/>
              </a:ext>
            </a:extLst>
          </p:cNvPr>
          <p:cNvSpPr txBox="1"/>
          <p:nvPr/>
        </p:nvSpPr>
        <p:spPr>
          <a:xfrm>
            <a:off x="8629208" y="527812"/>
            <a:ext cx="10595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b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2ECD784-B123-9447-9162-8FC26925B67B}"/>
              </a:ext>
            </a:extLst>
          </p:cNvPr>
          <p:cNvSpPr txBox="1"/>
          <p:nvPr/>
        </p:nvSpPr>
        <p:spPr>
          <a:xfrm rot="16200000">
            <a:off x="7838349" y="1373936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4615BFA-8733-D043-A902-9AEAA808529A}"/>
              </a:ext>
            </a:extLst>
          </p:cNvPr>
          <p:cNvCxnSpPr>
            <a:cxnSpLocks/>
          </p:cNvCxnSpPr>
          <p:nvPr/>
        </p:nvCxnSpPr>
        <p:spPr>
          <a:xfrm>
            <a:off x="8143708" y="834540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6374A716-9C7C-5740-ABFD-BED38D5FBF07}"/>
              </a:ext>
            </a:extLst>
          </p:cNvPr>
          <p:cNvSpPr txBox="1"/>
          <p:nvPr/>
        </p:nvSpPr>
        <p:spPr>
          <a:xfrm rot="16200000">
            <a:off x="8714412" y="1299982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396DF0D-65B5-9142-ADB1-C379DDA869DD}"/>
              </a:ext>
            </a:extLst>
          </p:cNvPr>
          <p:cNvSpPr txBox="1"/>
          <p:nvPr/>
        </p:nvSpPr>
        <p:spPr>
          <a:xfrm rot="16200000">
            <a:off x="8301571" y="1382818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FD56568-7D00-C44B-B045-7941C7614330}"/>
              </a:ext>
            </a:extLst>
          </p:cNvPr>
          <p:cNvSpPr txBox="1"/>
          <p:nvPr/>
        </p:nvSpPr>
        <p:spPr>
          <a:xfrm rot="16200000">
            <a:off x="9147661" y="1303586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960F4EE0-2B34-C64B-BE96-FA1904FAC7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94" t="27470" r="5541" b="59655"/>
          <a:stretch/>
        </p:blipFill>
        <p:spPr>
          <a:xfrm>
            <a:off x="1250945" y="1912152"/>
            <a:ext cx="8743327" cy="567531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5507947A-28FF-6642-B779-44694CF7E28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823" t="48560" r="3681" b="38607"/>
          <a:stretch/>
        </p:blipFill>
        <p:spPr>
          <a:xfrm>
            <a:off x="1250945" y="2735483"/>
            <a:ext cx="8743327" cy="567531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1F30B622-0ACA-9E42-BC87-DFB1F72E2CFC}"/>
              </a:ext>
            </a:extLst>
          </p:cNvPr>
          <p:cNvSpPr txBox="1"/>
          <p:nvPr/>
        </p:nvSpPr>
        <p:spPr>
          <a:xfrm>
            <a:off x="0" y="-48667"/>
            <a:ext cx="1163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  <a:r>
              <a:rPr lang="en-IL" dirty="0"/>
              <a:t>ep2 of experiment </a:t>
            </a:r>
            <a:r>
              <a:rPr lang="en-IL"/>
              <a:t>in </a:t>
            </a:r>
            <a:r>
              <a:rPr lang="en-US" dirty="0"/>
              <a:t>Extended Data Fig. 9</a:t>
            </a:r>
            <a:r>
              <a:rPr lang="en-IL"/>
              <a:t> </a:t>
            </a:r>
            <a:r>
              <a:rPr lang="en-IL" dirty="0"/>
              <a:t>with quantifications and </a:t>
            </a:r>
            <a:r>
              <a:rPr lang="en-IL"/>
              <a:t>raw file</a:t>
            </a:r>
            <a:endParaRPr lang="en-IL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951942D-88E3-9045-A79F-1F18C2AD553C}"/>
              </a:ext>
            </a:extLst>
          </p:cNvPr>
          <p:cNvSpPr txBox="1"/>
          <p:nvPr/>
        </p:nvSpPr>
        <p:spPr>
          <a:xfrm>
            <a:off x="1422328" y="2460900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8239400-163D-1841-88F2-70C135B0F589}"/>
              </a:ext>
            </a:extLst>
          </p:cNvPr>
          <p:cNvSpPr txBox="1"/>
          <p:nvPr/>
        </p:nvSpPr>
        <p:spPr>
          <a:xfrm>
            <a:off x="1795445" y="2455647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.0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7F5E92C-7C03-784C-9679-9BCFCBF8FA3C}"/>
              </a:ext>
            </a:extLst>
          </p:cNvPr>
          <p:cNvSpPr txBox="1"/>
          <p:nvPr/>
        </p:nvSpPr>
        <p:spPr>
          <a:xfrm>
            <a:off x="2289428" y="2455647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6DC324B-AF59-0F45-8E1E-A616F82023FB}"/>
              </a:ext>
            </a:extLst>
          </p:cNvPr>
          <p:cNvSpPr txBox="1"/>
          <p:nvPr/>
        </p:nvSpPr>
        <p:spPr>
          <a:xfrm>
            <a:off x="2730866" y="2466157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7E06BE3-EE85-3B4F-91CD-3D579DDB047A}"/>
              </a:ext>
            </a:extLst>
          </p:cNvPr>
          <p:cNvSpPr txBox="1"/>
          <p:nvPr/>
        </p:nvSpPr>
        <p:spPr>
          <a:xfrm>
            <a:off x="5904975" y="2466156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8C80C1C-463E-2A4C-A170-F2529FC08867}"/>
              </a:ext>
            </a:extLst>
          </p:cNvPr>
          <p:cNvSpPr txBox="1"/>
          <p:nvPr/>
        </p:nvSpPr>
        <p:spPr>
          <a:xfrm>
            <a:off x="6320133" y="2460903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560E705B-5DF9-7F45-8AAA-536190FE014D}"/>
              </a:ext>
            </a:extLst>
          </p:cNvPr>
          <p:cNvSpPr txBox="1"/>
          <p:nvPr/>
        </p:nvSpPr>
        <p:spPr>
          <a:xfrm>
            <a:off x="6803610" y="2460903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A7F6B4D-85BE-7548-B0F9-23EC209F96F9}"/>
              </a:ext>
            </a:extLst>
          </p:cNvPr>
          <p:cNvSpPr txBox="1"/>
          <p:nvPr/>
        </p:nvSpPr>
        <p:spPr>
          <a:xfrm>
            <a:off x="7213513" y="2450393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3A0ED1E-5438-E646-BD80-96836E1C0DF0}"/>
              </a:ext>
            </a:extLst>
          </p:cNvPr>
          <p:cNvSpPr txBox="1"/>
          <p:nvPr/>
        </p:nvSpPr>
        <p:spPr>
          <a:xfrm>
            <a:off x="3739851" y="2455647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119ECE9-B6A3-1749-B48B-2325A48424DF}"/>
              </a:ext>
            </a:extLst>
          </p:cNvPr>
          <p:cNvSpPr txBox="1"/>
          <p:nvPr/>
        </p:nvSpPr>
        <p:spPr>
          <a:xfrm>
            <a:off x="4102497" y="2460900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.14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5AD8951-B823-9040-9408-1A9882EC4A62}"/>
              </a:ext>
            </a:extLst>
          </p:cNvPr>
          <p:cNvSpPr txBox="1"/>
          <p:nvPr/>
        </p:nvSpPr>
        <p:spPr>
          <a:xfrm>
            <a:off x="4543893" y="245039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B749D78-E05E-214B-86F0-378666F9EB64}"/>
              </a:ext>
            </a:extLst>
          </p:cNvPr>
          <p:cNvSpPr txBox="1"/>
          <p:nvPr/>
        </p:nvSpPr>
        <p:spPr>
          <a:xfrm>
            <a:off x="4943285" y="246090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4FA21C5-D9C7-E945-B037-6AED2FA1A716}"/>
              </a:ext>
            </a:extLst>
          </p:cNvPr>
          <p:cNvSpPr txBox="1"/>
          <p:nvPr/>
        </p:nvSpPr>
        <p:spPr>
          <a:xfrm>
            <a:off x="8206728" y="2455647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8EB844E-8327-AF41-93B6-B8864B260A8F}"/>
              </a:ext>
            </a:extLst>
          </p:cNvPr>
          <p:cNvSpPr txBox="1"/>
          <p:nvPr/>
        </p:nvSpPr>
        <p:spPr>
          <a:xfrm>
            <a:off x="8590353" y="245039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2ADDA18-A2B2-044F-B68D-C45B27F9668F}"/>
              </a:ext>
            </a:extLst>
          </p:cNvPr>
          <p:cNvSpPr txBox="1"/>
          <p:nvPr/>
        </p:nvSpPr>
        <p:spPr>
          <a:xfrm>
            <a:off x="9094850" y="245039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96D95FC-816D-2E41-A38D-1F2477092FFD}"/>
              </a:ext>
            </a:extLst>
          </p:cNvPr>
          <p:cNvSpPr txBox="1"/>
          <p:nvPr/>
        </p:nvSpPr>
        <p:spPr>
          <a:xfrm>
            <a:off x="9557303" y="246090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631BADB9-6A86-704A-B8AD-9B7E0527CE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5859" y="4140650"/>
            <a:ext cx="3741738" cy="2022162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4FE6A253-742F-714D-B1DE-7116349EC3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0945" y="4141006"/>
            <a:ext cx="3724419" cy="2034143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F7649F43-430B-D14E-B612-E8621BE03BE8}"/>
              </a:ext>
            </a:extLst>
          </p:cNvPr>
          <p:cNvSpPr txBox="1"/>
          <p:nvPr/>
        </p:nvSpPr>
        <p:spPr>
          <a:xfrm>
            <a:off x="5171971" y="4997894"/>
            <a:ext cx="764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35D6CE3F-7692-CF42-B489-648C19195DEE}"/>
              </a:ext>
            </a:extLst>
          </p:cNvPr>
          <p:cNvCxnSpPr/>
          <p:nvPr/>
        </p:nvCxnSpPr>
        <p:spPr>
          <a:xfrm flipH="1">
            <a:off x="4873797" y="5151783"/>
            <a:ext cx="298174" cy="695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7CC12675-C15B-9542-8118-1479B9E975E0}"/>
              </a:ext>
            </a:extLst>
          </p:cNvPr>
          <p:cNvSpPr txBox="1"/>
          <p:nvPr/>
        </p:nvSpPr>
        <p:spPr>
          <a:xfrm>
            <a:off x="10386842" y="4553946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DM4</a:t>
            </a:r>
          </a:p>
        </p:txBody>
      </p: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77E55BCD-EB51-5446-83FA-1347A3D3CA30}"/>
              </a:ext>
            </a:extLst>
          </p:cNvPr>
          <p:cNvCxnSpPr/>
          <p:nvPr/>
        </p:nvCxnSpPr>
        <p:spPr>
          <a:xfrm flipH="1">
            <a:off x="10088668" y="4707835"/>
            <a:ext cx="298174" cy="695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47640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9781AAE-A713-AB4D-A658-56F99A566CD2}"/>
              </a:ext>
            </a:extLst>
          </p:cNvPr>
          <p:cNvSpPr txBox="1"/>
          <p:nvPr/>
        </p:nvSpPr>
        <p:spPr>
          <a:xfrm>
            <a:off x="9995337" y="3088564"/>
            <a:ext cx="764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6257AE-37A2-C44E-8427-57470A43F11E}"/>
              </a:ext>
            </a:extLst>
          </p:cNvPr>
          <p:cNvSpPr txBox="1"/>
          <p:nvPr/>
        </p:nvSpPr>
        <p:spPr>
          <a:xfrm>
            <a:off x="8824575" y="536511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F0ED3AC-A08B-0241-BDD6-EF37BE540E6B}"/>
              </a:ext>
            </a:extLst>
          </p:cNvPr>
          <p:cNvSpPr txBox="1"/>
          <p:nvPr/>
        </p:nvSpPr>
        <p:spPr>
          <a:xfrm rot="16200000">
            <a:off x="1139545" y="1275917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B2EC78-D14F-1740-80BF-292FFB627F40}"/>
              </a:ext>
            </a:extLst>
          </p:cNvPr>
          <p:cNvSpPr txBox="1"/>
          <p:nvPr/>
        </p:nvSpPr>
        <p:spPr>
          <a:xfrm>
            <a:off x="9995337" y="2030018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DM4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1C80C41-929B-4E49-AEAB-A36E814947BD}"/>
              </a:ext>
            </a:extLst>
          </p:cNvPr>
          <p:cNvCxnSpPr>
            <a:cxnSpLocks/>
          </p:cNvCxnSpPr>
          <p:nvPr/>
        </p:nvCxnSpPr>
        <p:spPr>
          <a:xfrm>
            <a:off x="1453897" y="829283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4C3C7CE6-1F94-0845-A2DE-E9B778487AA8}"/>
              </a:ext>
            </a:extLst>
          </p:cNvPr>
          <p:cNvSpPr txBox="1"/>
          <p:nvPr/>
        </p:nvSpPr>
        <p:spPr>
          <a:xfrm rot="16200000">
            <a:off x="1936690" y="1257785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932C886-FE29-1046-A67F-CA58BA45475C}"/>
              </a:ext>
            </a:extLst>
          </p:cNvPr>
          <p:cNvSpPr txBox="1"/>
          <p:nvPr/>
        </p:nvSpPr>
        <p:spPr>
          <a:xfrm rot="16200000">
            <a:off x="1539669" y="1264120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0B6856-3703-DF46-83B5-463505DBC29E}"/>
              </a:ext>
            </a:extLst>
          </p:cNvPr>
          <p:cNvSpPr txBox="1"/>
          <p:nvPr/>
        </p:nvSpPr>
        <p:spPr>
          <a:xfrm rot="16200000">
            <a:off x="2358440" y="122964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843B1D-2779-224A-990A-713FFB64ACF9}"/>
              </a:ext>
            </a:extLst>
          </p:cNvPr>
          <p:cNvSpPr txBox="1"/>
          <p:nvPr/>
        </p:nvSpPr>
        <p:spPr>
          <a:xfrm>
            <a:off x="6497063" y="536511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D3D560-D096-734D-A1B4-B3D61B2934B3}"/>
              </a:ext>
            </a:extLst>
          </p:cNvPr>
          <p:cNvSpPr txBox="1"/>
          <p:nvPr/>
        </p:nvSpPr>
        <p:spPr>
          <a:xfrm rot="16200000">
            <a:off x="3379895" y="1289952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F5F83E7-070C-CC4A-A288-B69C24151244}"/>
              </a:ext>
            </a:extLst>
          </p:cNvPr>
          <p:cNvCxnSpPr>
            <a:cxnSpLocks/>
          </p:cNvCxnSpPr>
          <p:nvPr/>
        </p:nvCxnSpPr>
        <p:spPr>
          <a:xfrm>
            <a:off x="3624279" y="834538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F53A856-AE7C-7B45-930B-A81E1A6C6AB2}"/>
              </a:ext>
            </a:extLst>
          </p:cNvPr>
          <p:cNvSpPr txBox="1"/>
          <p:nvPr/>
        </p:nvSpPr>
        <p:spPr>
          <a:xfrm rot="16200000">
            <a:off x="4224511" y="121060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A86CC8E-EE93-E649-B111-A620A4071DA0}"/>
              </a:ext>
            </a:extLst>
          </p:cNvPr>
          <p:cNvSpPr txBox="1"/>
          <p:nvPr/>
        </p:nvSpPr>
        <p:spPr>
          <a:xfrm rot="16200000">
            <a:off x="3828274" y="1298066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7E6E487-77AB-164D-BD5E-43755FFDB73B}"/>
              </a:ext>
            </a:extLst>
          </p:cNvPr>
          <p:cNvSpPr txBox="1"/>
          <p:nvPr/>
        </p:nvSpPr>
        <p:spPr>
          <a:xfrm rot="16200000">
            <a:off x="4716983" y="121060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277DD21-39F1-5C44-8AF4-E1C907A80B60}"/>
              </a:ext>
            </a:extLst>
          </p:cNvPr>
          <p:cNvSpPr txBox="1"/>
          <p:nvPr/>
        </p:nvSpPr>
        <p:spPr>
          <a:xfrm>
            <a:off x="3899807" y="536511"/>
            <a:ext cx="1008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 9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E248482-2829-F945-8709-18CD82CD0B28}"/>
              </a:ext>
            </a:extLst>
          </p:cNvPr>
          <p:cNvSpPr txBox="1"/>
          <p:nvPr/>
        </p:nvSpPr>
        <p:spPr>
          <a:xfrm rot="16200000">
            <a:off x="5639053" y="1307586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6080645-4339-6644-B495-C48370698C39}"/>
              </a:ext>
            </a:extLst>
          </p:cNvPr>
          <p:cNvCxnSpPr>
            <a:cxnSpLocks/>
          </p:cNvCxnSpPr>
          <p:nvPr/>
        </p:nvCxnSpPr>
        <p:spPr>
          <a:xfrm>
            <a:off x="5936546" y="834541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0258CA3-8B98-754D-B600-9F83B3329FF8}"/>
              </a:ext>
            </a:extLst>
          </p:cNvPr>
          <p:cNvSpPr txBox="1"/>
          <p:nvPr/>
        </p:nvSpPr>
        <p:spPr>
          <a:xfrm rot="16200000">
            <a:off x="6473296" y="125277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372631D-B5CE-9148-88D0-99E448210EED}"/>
              </a:ext>
            </a:extLst>
          </p:cNvPr>
          <p:cNvSpPr txBox="1"/>
          <p:nvPr/>
        </p:nvSpPr>
        <p:spPr>
          <a:xfrm rot="16200000">
            <a:off x="6109422" y="1323624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F09FBBB-366A-A747-AC41-8095A6CB2031}"/>
              </a:ext>
            </a:extLst>
          </p:cNvPr>
          <p:cNvSpPr txBox="1"/>
          <p:nvPr/>
        </p:nvSpPr>
        <p:spPr>
          <a:xfrm rot="16200000">
            <a:off x="6946539" y="1218797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D055530-7002-524A-BD16-D21F944FB76E}"/>
              </a:ext>
            </a:extLst>
          </p:cNvPr>
          <p:cNvSpPr txBox="1"/>
          <p:nvPr/>
        </p:nvSpPr>
        <p:spPr>
          <a:xfrm>
            <a:off x="1724895" y="536511"/>
            <a:ext cx="10595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CaP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b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2ECD784-B123-9447-9162-8FC26925B67B}"/>
              </a:ext>
            </a:extLst>
          </p:cNvPr>
          <p:cNvSpPr txBox="1"/>
          <p:nvPr/>
        </p:nvSpPr>
        <p:spPr>
          <a:xfrm rot="16200000">
            <a:off x="7852606" y="1287645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3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4615BFA-8733-D043-A902-9AEAA808529A}"/>
              </a:ext>
            </a:extLst>
          </p:cNvPr>
          <p:cNvCxnSpPr>
            <a:cxnSpLocks/>
          </p:cNvCxnSpPr>
          <p:nvPr/>
        </p:nvCxnSpPr>
        <p:spPr>
          <a:xfrm>
            <a:off x="8143708" y="834540"/>
            <a:ext cx="177654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6374A716-9C7C-5740-ABFD-BED38D5FBF07}"/>
              </a:ext>
            </a:extLst>
          </p:cNvPr>
          <p:cNvSpPr txBox="1"/>
          <p:nvPr/>
        </p:nvSpPr>
        <p:spPr>
          <a:xfrm rot="16200000">
            <a:off x="8690489" y="1229642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396DF0D-65B5-9142-ADB1-C379DDA869DD}"/>
              </a:ext>
            </a:extLst>
          </p:cNvPr>
          <p:cNvSpPr txBox="1"/>
          <p:nvPr/>
        </p:nvSpPr>
        <p:spPr>
          <a:xfrm rot="16200000">
            <a:off x="8301923" y="1289952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GFP-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FD56568-7D00-C44B-B045-7941C7614330}"/>
              </a:ext>
            </a:extLst>
          </p:cNvPr>
          <p:cNvSpPr txBox="1"/>
          <p:nvPr/>
        </p:nvSpPr>
        <p:spPr>
          <a:xfrm rot="16200000">
            <a:off x="9152258" y="1218796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gMDM4-2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50B1207E-9209-AA4B-96E8-A95957EF42B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16" t="45371" r="6171" b="38563"/>
          <a:stretch/>
        </p:blipFill>
        <p:spPr>
          <a:xfrm>
            <a:off x="1385625" y="2774490"/>
            <a:ext cx="8561359" cy="56800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31E2E8E3-40CF-5144-A214-393B6C959ACF}"/>
              </a:ext>
            </a:extLst>
          </p:cNvPr>
          <p:cNvSpPr txBox="1"/>
          <p:nvPr/>
        </p:nvSpPr>
        <p:spPr>
          <a:xfrm>
            <a:off x="1477637" y="246107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709BC6F-76D0-7D4E-838D-CDD6488C5A11}"/>
              </a:ext>
            </a:extLst>
          </p:cNvPr>
          <p:cNvSpPr txBox="1"/>
          <p:nvPr/>
        </p:nvSpPr>
        <p:spPr>
          <a:xfrm>
            <a:off x="1924325" y="2466328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DFFD2C4-AA1E-164A-A505-1E02AFCF7DA7}"/>
              </a:ext>
            </a:extLst>
          </p:cNvPr>
          <p:cNvSpPr txBox="1"/>
          <p:nvPr/>
        </p:nvSpPr>
        <p:spPr>
          <a:xfrm>
            <a:off x="2292183" y="2466327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EF85743-2AB2-E34A-B693-75334166747D}"/>
              </a:ext>
            </a:extLst>
          </p:cNvPr>
          <p:cNvSpPr txBox="1"/>
          <p:nvPr/>
        </p:nvSpPr>
        <p:spPr>
          <a:xfrm>
            <a:off x="2733619" y="2455818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74CD42F-4413-E641-A63A-999F401309AD}"/>
              </a:ext>
            </a:extLst>
          </p:cNvPr>
          <p:cNvSpPr txBox="1"/>
          <p:nvPr/>
        </p:nvSpPr>
        <p:spPr>
          <a:xfrm>
            <a:off x="3732098" y="2466328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DC24513-E4DF-B94C-9708-CF1AEE159C7C}"/>
              </a:ext>
            </a:extLst>
          </p:cNvPr>
          <p:cNvSpPr txBox="1"/>
          <p:nvPr/>
        </p:nvSpPr>
        <p:spPr>
          <a:xfrm>
            <a:off x="4136747" y="2471583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56358A2-6DAB-E84A-A96F-8D4B1B409724}"/>
              </a:ext>
            </a:extLst>
          </p:cNvPr>
          <p:cNvSpPr txBox="1"/>
          <p:nvPr/>
        </p:nvSpPr>
        <p:spPr>
          <a:xfrm>
            <a:off x="4683280" y="2471585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D7C9BCC-5489-1E4E-BB8D-B060063CAF21}"/>
              </a:ext>
            </a:extLst>
          </p:cNvPr>
          <p:cNvSpPr txBox="1"/>
          <p:nvPr/>
        </p:nvSpPr>
        <p:spPr>
          <a:xfrm>
            <a:off x="5082678" y="2471585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F4ECA5F-7E79-5640-90D5-6CCE230031C5}"/>
              </a:ext>
            </a:extLst>
          </p:cNvPr>
          <p:cNvSpPr txBox="1"/>
          <p:nvPr/>
        </p:nvSpPr>
        <p:spPr>
          <a:xfrm>
            <a:off x="6049626" y="2471583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5A0CFC4-D171-B946-9C00-A6357D7D50EA}"/>
              </a:ext>
            </a:extLst>
          </p:cNvPr>
          <p:cNvSpPr txBox="1"/>
          <p:nvPr/>
        </p:nvSpPr>
        <p:spPr>
          <a:xfrm>
            <a:off x="6459526" y="2461075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ADBB478-7737-0E45-800E-F29A7A3ED66A}"/>
              </a:ext>
            </a:extLst>
          </p:cNvPr>
          <p:cNvSpPr txBox="1"/>
          <p:nvPr/>
        </p:nvSpPr>
        <p:spPr>
          <a:xfrm>
            <a:off x="6879938" y="246107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CF563F0-28E5-A24E-9504-D4B85658406B}"/>
              </a:ext>
            </a:extLst>
          </p:cNvPr>
          <p:cNvSpPr txBox="1"/>
          <p:nvPr/>
        </p:nvSpPr>
        <p:spPr>
          <a:xfrm>
            <a:off x="7289840" y="2461074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00A354B-06C0-8B44-8E7A-38E2388140D4}"/>
              </a:ext>
            </a:extLst>
          </p:cNvPr>
          <p:cNvSpPr txBox="1"/>
          <p:nvPr/>
        </p:nvSpPr>
        <p:spPr>
          <a:xfrm>
            <a:off x="8188470" y="2455822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4A42F31-A81C-224E-8F8E-66D9732932F6}"/>
              </a:ext>
            </a:extLst>
          </p:cNvPr>
          <p:cNvSpPr txBox="1"/>
          <p:nvPr/>
        </p:nvSpPr>
        <p:spPr>
          <a:xfrm>
            <a:off x="8566845" y="2455821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1.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255E30F-EB4C-834B-9AA2-F34AE1497804}"/>
              </a:ext>
            </a:extLst>
          </p:cNvPr>
          <p:cNvSpPr txBox="1"/>
          <p:nvPr/>
        </p:nvSpPr>
        <p:spPr>
          <a:xfrm>
            <a:off x="9018792" y="2455820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DB0EF24-95EA-BA43-A74D-8E14BD1DB53D}"/>
              </a:ext>
            </a:extLst>
          </p:cNvPr>
          <p:cNvSpPr txBox="1"/>
          <p:nvPr/>
        </p:nvSpPr>
        <p:spPr>
          <a:xfrm>
            <a:off x="9512770" y="2455820"/>
            <a:ext cx="488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EFE8BC5F-D0C6-6545-897D-CC3AD38355D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541" t="25903" r="4203" b="62043"/>
          <a:stretch/>
        </p:blipFill>
        <p:spPr>
          <a:xfrm>
            <a:off x="1358894" y="1863652"/>
            <a:ext cx="8614823" cy="61357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EEE3C9C-4C79-5D48-961C-F3126B011582}"/>
              </a:ext>
            </a:extLst>
          </p:cNvPr>
          <p:cNvSpPr txBox="1"/>
          <p:nvPr/>
        </p:nvSpPr>
        <p:spPr>
          <a:xfrm>
            <a:off x="-33226" y="29207"/>
            <a:ext cx="12149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dirty="0"/>
              <a:t>Rep3 of experiment </a:t>
            </a:r>
            <a:r>
              <a:rPr lang="en-IL"/>
              <a:t>in </a:t>
            </a:r>
            <a:r>
              <a:rPr lang="en-US" dirty="0"/>
              <a:t>Extended Data Fig. 9</a:t>
            </a:r>
            <a:r>
              <a:rPr lang="en-IL"/>
              <a:t> </a:t>
            </a:r>
            <a:r>
              <a:rPr lang="en-IL" dirty="0"/>
              <a:t>with quantifications and </a:t>
            </a:r>
            <a:r>
              <a:rPr lang="en-IL"/>
              <a:t>raw file</a:t>
            </a:r>
            <a:endParaRPr lang="en-IL" dirty="0"/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217AB439-1DBE-954F-BE07-363FB7E4781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99926" y="4177780"/>
            <a:ext cx="4631157" cy="2309469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2382B563-A5BD-CB42-8CD3-62A2AE86EE20}"/>
              </a:ext>
            </a:extLst>
          </p:cNvPr>
          <p:cNvSpPr txBox="1"/>
          <p:nvPr/>
        </p:nvSpPr>
        <p:spPr>
          <a:xfrm>
            <a:off x="11569148" y="4636772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DM4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CF797FDD-C0AD-2549-8457-4D0BCE5E35CD}"/>
              </a:ext>
            </a:extLst>
          </p:cNvPr>
          <p:cNvCxnSpPr/>
          <p:nvPr/>
        </p:nvCxnSpPr>
        <p:spPr>
          <a:xfrm flipH="1">
            <a:off x="11270974" y="4790661"/>
            <a:ext cx="298174" cy="695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74770C9E-6F9C-0941-AEF2-ABFB62689F98}"/>
              </a:ext>
            </a:extLst>
          </p:cNvPr>
          <p:cNvSpPr txBox="1"/>
          <p:nvPr/>
        </p:nvSpPr>
        <p:spPr>
          <a:xfrm>
            <a:off x="10398170" y="4269137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BCBFD62-458B-5D42-BDB8-B2EFFCBCC82B}"/>
              </a:ext>
            </a:extLst>
          </p:cNvPr>
          <p:cNvSpPr txBox="1"/>
          <p:nvPr/>
        </p:nvSpPr>
        <p:spPr>
          <a:xfrm>
            <a:off x="9314756" y="4269137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4F5B78A-FFD0-B446-A88D-80314A363324}"/>
              </a:ext>
            </a:extLst>
          </p:cNvPr>
          <p:cNvSpPr txBox="1"/>
          <p:nvPr/>
        </p:nvSpPr>
        <p:spPr>
          <a:xfrm>
            <a:off x="7034133" y="4365019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bl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397ED55-8800-DA44-B2FC-DC6B1532816B}"/>
              </a:ext>
            </a:extLst>
          </p:cNvPr>
          <p:cNvSpPr txBox="1"/>
          <p:nvPr/>
        </p:nvSpPr>
        <p:spPr>
          <a:xfrm>
            <a:off x="8185178" y="4272482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95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Picture 77">
            <a:extLst>
              <a:ext uri="{FF2B5EF4-FFF2-40B4-BE49-F238E27FC236}">
                <a16:creationId xmlns:a16="http://schemas.microsoft.com/office/drawing/2014/main" id="{6A749083-20C5-2740-AB2A-1D98144C0D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443" y="4051891"/>
            <a:ext cx="4423074" cy="2348535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DD9A0AD3-F833-2C45-AEDA-B06FDBE00607}"/>
              </a:ext>
            </a:extLst>
          </p:cNvPr>
          <p:cNvSpPr txBox="1"/>
          <p:nvPr/>
        </p:nvSpPr>
        <p:spPr>
          <a:xfrm>
            <a:off x="5171971" y="4997894"/>
            <a:ext cx="764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069E6103-3BC5-BA42-8A77-90401BCE1C15}"/>
              </a:ext>
            </a:extLst>
          </p:cNvPr>
          <p:cNvCxnSpPr/>
          <p:nvPr/>
        </p:nvCxnSpPr>
        <p:spPr>
          <a:xfrm flipH="1">
            <a:off x="4873797" y="5151783"/>
            <a:ext cx="298174" cy="695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9F9A2314-B7EA-0F48-834F-87C7BA36E7FE}"/>
              </a:ext>
            </a:extLst>
          </p:cNvPr>
          <p:cNvSpPr txBox="1"/>
          <p:nvPr/>
        </p:nvSpPr>
        <p:spPr>
          <a:xfrm>
            <a:off x="4053102" y="4177780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4-2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7DD6CAB-E6C4-0241-B9A9-43D8CC89E622}"/>
              </a:ext>
            </a:extLst>
          </p:cNvPr>
          <p:cNvSpPr txBox="1"/>
          <p:nvPr/>
        </p:nvSpPr>
        <p:spPr>
          <a:xfrm>
            <a:off x="2898753" y="4177780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4C49812-5598-774D-A57E-D01124815524}"/>
              </a:ext>
            </a:extLst>
          </p:cNvPr>
          <p:cNvSpPr txBox="1"/>
          <p:nvPr/>
        </p:nvSpPr>
        <p:spPr>
          <a:xfrm>
            <a:off x="961814" y="4103409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bl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0CFE42E-42AF-4846-964A-D6ED45F38581}"/>
              </a:ext>
            </a:extLst>
          </p:cNvPr>
          <p:cNvSpPr txBox="1"/>
          <p:nvPr/>
        </p:nvSpPr>
        <p:spPr>
          <a:xfrm>
            <a:off x="1879220" y="4120763"/>
            <a:ext cx="884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NCaP 95</a:t>
            </a:r>
            <a:endParaRPr lang="en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424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04</Words>
  <Application>Microsoft Macintosh PowerPoint</Application>
  <PresentationFormat>Widescreen</PresentationFormat>
  <Paragraphs>14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marakeby, Haitham A.</dc:creator>
  <cp:lastModifiedBy>Elmarakeby, Haitham A.</cp:lastModifiedBy>
  <cp:revision>6</cp:revision>
  <dcterms:created xsi:type="dcterms:W3CDTF">2021-04-20T14:13:29Z</dcterms:created>
  <dcterms:modified xsi:type="dcterms:W3CDTF">2021-08-05T06:31:20Z</dcterms:modified>
</cp:coreProperties>
</file>